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8"/>
  </p:notesMasterIdLst>
  <p:sldIdLst>
    <p:sldId id="258" r:id="rId2"/>
    <p:sldId id="257" r:id="rId3"/>
    <p:sldId id="260" r:id="rId4"/>
    <p:sldId id="262" r:id="rId5"/>
    <p:sldId id="261" r:id="rId6"/>
    <p:sldId id="259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041"/>
    <p:restoredTop sz="94694"/>
  </p:normalViewPr>
  <p:slideViewPr>
    <p:cSldViewPr snapToGrid="0" snapToObjects="1">
      <p:cViewPr varScale="1">
        <p:scale>
          <a:sx n="91" d="100"/>
          <a:sy n="91" d="100"/>
        </p:scale>
        <p:origin x="624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7BC697F-2E7F-7946-A9CD-2BDB2A851F02}" type="datetimeFigureOut">
              <a:rPr lang="en-US" smtClean="0"/>
              <a:t>4/12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34EE6B5-32D4-F641-82B8-A302DA69B5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18467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34EE6B5-32D4-F641-82B8-A302DA69B59B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252215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34EE6B5-32D4-F641-82B8-A302DA69B59B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444205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34EE6B5-32D4-F641-82B8-A302DA69B59B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488690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34EE6B5-32D4-F641-82B8-A302DA69B59B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3981604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34EE6B5-32D4-F641-82B8-A302DA69B59B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86172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6FFAB1-B929-2546-92A1-52716611EC6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F2AC6C6-B879-DD45-AB3B-00BBCCDC81D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3F6D8C4-0688-494B-BACB-8420F13703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E5B64-4D9D-D540-92AA-5465A4584814}" type="datetimeFigureOut">
              <a:rPr lang="en-US" smtClean="0"/>
              <a:t>4/1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E80724-8ADF-1849-B95E-1D36AEAAC4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9317EBB-DAC9-1145-A70E-2444520AA0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9F94A-3D6F-0645-A1D5-3346B91419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35565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60193E-AF59-C440-9F8C-33CBBB0034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D542994-32B2-E14D-8089-F1114753ADE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3A0F737-BD4C-694A-9F64-C4FF8DAEB0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E5B64-4D9D-D540-92AA-5465A4584814}" type="datetimeFigureOut">
              <a:rPr lang="en-US" smtClean="0"/>
              <a:t>4/1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F2355B6-A8E0-AA4E-B05B-0457ED4193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0D64E5-B100-0A45-9338-A101552479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9F94A-3D6F-0645-A1D5-3346B91419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71620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6A5DDE9-062E-7D4F-A212-398347A396A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2FD83BA-A490-E644-A0C2-49AFC17B600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4A7F208-C646-B848-82C0-3407E5DED7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E5B64-4D9D-D540-92AA-5465A4584814}" type="datetimeFigureOut">
              <a:rPr lang="en-US" smtClean="0"/>
              <a:t>4/1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D14062D-0FDE-114E-9FF4-5142EA18D9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CDF79A-44BE-CB48-A747-9DD2DFFFD9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9F94A-3D6F-0645-A1D5-3346B91419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82206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BA1E75-2CA4-174E-BB2A-2A7A4B9467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0867655-A558-B040-A0D3-80A810A2E0C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8FB7923-CDB9-C94B-9AFF-8F55EDF090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E5B64-4D9D-D540-92AA-5465A4584814}" type="datetimeFigureOut">
              <a:rPr lang="en-US" smtClean="0"/>
              <a:t>4/1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1846211-59E8-2D4E-BB1A-E53CF04B92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3F7B8D9-F941-1E45-9340-556F67FD26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9F94A-3D6F-0645-A1D5-3346B91419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18473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7748AA-D48D-5148-8317-7EB5A33A8F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C30F9B4-830F-924D-8B3C-9FC6303AE61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9D67DB-30A0-8F42-A1BC-52C252720F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E5B64-4D9D-D540-92AA-5465A4584814}" type="datetimeFigureOut">
              <a:rPr lang="en-US" smtClean="0"/>
              <a:t>4/1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044A92-F03E-7643-8A32-FCC93301A9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13B8C84-5B6E-8846-9F24-E6C2035DCF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9F94A-3D6F-0645-A1D5-3346B91419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60953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5B73CE-8C19-FF46-9E02-EEEAFA289F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C2383A0-FF73-5A47-BA7C-20D3E27E373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793C99F-0CCB-404F-B620-6F13B6C135C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515306C-2A77-394C-8DCE-9CCF69886E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E5B64-4D9D-D540-92AA-5465A4584814}" type="datetimeFigureOut">
              <a:rPr lang="en-US" smtClean="0"/>
              <a:t>4/12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A5602E8-B1AE-DA41-9074-A5AE66BE84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95E9B8D-7F54-0344-97FD-2192830C1D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9F94A-3D6F-0645-A1D5-3346B91419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99388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67B665-2C26-2E44-93BD-442B563FFE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EF6B515-12D5-4244-9D02-BF8B8129680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7E914EA-9951-C841-A585-8F36F702C85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AD8AE33-9A38-D948-9BC3-733C057B832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B25DD88-28D0-3142-B521-9E199CDC9E7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C5D45F6-AAC1-E047-9680-8DED1F5B9F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E5B64-4D9D-D540-92AA-5465A4584814}" type="datetimeFigureOut">
              <a:rPr lang="en-US" smtClean="0"/>
              <a:t>4/12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CE96193-2AD2-CE47-93EF-3102E6546B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8D105A4-B003-EB4E-9212-416D94FE1E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9F94A-3D6F-0645-A1D5-3346B91419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10902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BC65A6-4634-D244-8548-01C3A590E6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026F4CC-F29D-5F45-A940-DC088C8CEE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E5B64-4D9D-D540-92AA-5465A4584814}" type="datetimeFigureOut">
              <a:rPr lang="en-US" smtClean="0"/>
              <a:t>4/12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F79AC53-48B6-0A4B-B8C1-1A9AFF799B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9DF5744-D893-B94F-9A34-DE78278852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9F94A-3D6F-0645-A1D5-3346B91419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94967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A0B3EC6-CA41-4343-9265-9ECF23B3ED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E5B64-4D9D-D540-92AA-5465A4584814}" type="datetimeFigureOut">
              <a:rPr lang="en-US" smtClean="0"/>
              <a:t>4/12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28FBE97-8D8F-3342-8212-6F086485E8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9B65E4A-E64B-964E-8E26-78C354E273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9F94A-3D6F-0645-A1D5-3346B91419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65785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68B2F9-EBE6-C94A-8445-FD79366E98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7DEB9EC-935E-2F4B-B17B-E3F8AEFEEA2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37FC335-8795-3840-A726-4A3C2C5826F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F96F1F4-92DF-044D-8D1D-3AE1CA35C5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E5B64-4D9D-D540-92AA-5465A4584814}" type="datetimeFigureOut">
              <a:rPr lang="en-US" smtClean="0"/>
              <a:t>4/12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CCE015C-1B22-2946-92A0-B4692E9680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ACBCC32-60B2-F240-B2B3-D51EFF0BE1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9F94A-3D6F-0645-A1D5-3346B91419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87689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42CB9B-AE6C-BC49-A771-1F01B17D07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2C84489-0B4B-AC4D-9E4E-5698272D191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72FC1A1-0F34-8042-B420-9149FB00D9B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0B09ACE-C0A0-9445-A261-551F6051F8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E5B64-4D9D-D540-92AA-5465A4584814}" type="datetimeFigureOut">
              <a:rPr lang="en-US" smtClean="0"/>
              <a:t>4/12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EFC3621-BCEA-4648-A125-E508C71B26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8605B12-1F3E-EA49-A2B4-0398F4D1DC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9F94A-3D6F-0645-A1D5-3346B91419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95486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3B41CF5-15DB-164A-AC60-F538087526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DCAEC21-96B9-AF4C-ADCE-F6000D0963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35FC61-BA5B-AE45-A12D-C7E2E61AA07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AE5B64-4D9D-D540-92AA-5465A4584814}" type="datetimeFigureOut">
              <a:rPr lang="en-US" smtClean="0"/>
              <a:t>4/1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2690C5F-AFC3-3F4E-8CD0-2BF2A6BEE41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9071C9-098F-7046-A463-99CD69F9F97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99F94A-3D6F-0645-A1D5-3346B91419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18918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9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0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1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2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40">
            <a:extLst>
              <a:ext uri="{FF2B5EF4-FFF2-40B4-BE49-F238E27FC236}">
                <a16:creationId xmlns:a16="http://schemas.microsoft.com/office/drawing/2014/main" id="{C2BE5FF5-D27B-40F4-A5D8-09B7620E0EF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80255"/>
          <a:stretch/>
        </p:blipFill>
        <p:spPr>
          <a:xfrm>
            <a:off x="4450832" y="4530944"/>
            <a:ext cx="1390676" cy="410613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42" name="Picture 41">
            <a:extLst>
              <a:ext uri="{FF2B5EF4-FFF2-40B4-BE49-F238E27FC236}">
                <a16:creationId xmlns:a16="http://schemas.microsoft.com/office/drawing/2014/main" id="{4A45F5E5-8F5E-401C-942C-BF7794B3536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106" r="78454"/>
          <a:stretch/>
        </p:blipFill>
        <p:spPr>
          <a:xfrm>
            <a:off x="4450830" y="5036551"/>
            <a:ext cx="1390676" cy="311520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43" name="Picture 42">
            <a:extLst>
              <a:ext uri="{FF2B5EF4-FFF2-40B4-BE49-F238E27FC236}">
                <a16:creationId xmlns:a16="http://schemas.microsoft.com/office/drawing/2014/main" id="{4320F1A6-2D3E-4EC2-A041-F81FCF46D4E5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79561"/>
          <a:stretch/>
        </p:blipFill>
        <p:spPr>
          <a:xfrm>
            <a:off x="4450831" y="6201142"/>
            <a:ext cx="1390676" cy="440191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44" name="Picture 43">
            <a:extLst>
              <a:ext uri="{FF2B5EF4-FFF2-40B4-BE49-F238E27FC236}">
                <a16:creationId xmlns:a16="http://schemas.microsoft.com/office/drawing/2014/main" id="{3434FC86-C98C-4FE5-B65A-C861C8BEFC63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79561"/>
          <a:stretch/>
        </p:blipFill>
        <p:spPr>
          <a:xfrm>
            <a:off x="4450831" y="5435044"/>
            <a:ext cx="1390676" cy="679125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45" name="Picture 44">
            <a:extLst>
              <a:ext uri="{FF2B5EF4-FFF2-40B4-BE49-F238E27FC236}">
                <a16:creationId xmlns:a16="http://schemas.microsoft.com/office/drawing/2014/main" id="{2D551A03-3F98-4E68-A91A-22BD604D7981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r="80255" b="17626"/>
          <a:stretch/>
        </p:blipFill>
        <p:spPr>
          <a:xfrm>
            <a:off x="4450830" y="4066900"/>
            <a:ext cx="1390677" cy="357318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46" name="Picture 45">
            <a:extLst>
              <a:ext uri="{FF2B5EF4-FFF2-40B4-BE49-F238E27FC236}">
                <a16:creationId xmlns:a16="http://schemas.microsoft.com/office/drawing/2014/main" id="{35352318-5608-489A-A7E3-36BD309798E5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r="80255" b="18933"/>
          <a:stretch/>
        </p:blipFill>
        <p:spPr>
          <a:xfrm>
            <a:off x="4450830" y="3368494"/>
            <a:ext cx="1390677" cy="602341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sp>
        <p:nvSpPr>
          <p:cNvPr id="47" name="TextBox 46">
            <a:extLst>
              <a:ext uri="{FF2B5EF4-FFF2-40B4-BE49-F238E27FC236}">
                <a16:creationId xmlns:a16="http://schemas.microsoft.com/office/drawing/2014/main" id="{F7F3C640-D257-4098-817E-7630C1D33923}"/>
              </a:ext>
            </a:extLst>
          </p:cNvPr>
          <p:cNvSpPr txBox="1"/>
          <p:nvPr/>
        </p:nvSpPr>
        <p:spPr>
          <a:xfrm>
            <a:off x="2599929" y="2824637"/>
            <a:ext cx="177548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BRD4 Iso A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04CB7988-309D-4692-A171-B82579F24CE9}"/>
              </a:ext>
            </a:extLst>
          </p:cNvPr>
          <p:cNvSpPr txBox="1"/>
          <p:nvPr/>
        </p:nvSpPr>
        <p:spPr>
          <a:xfrm>
            <a:off x="2565303" y="3462895"/>
            <a:ext cx="181011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BRD4 Iso C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AD18412F-5829-49FB-8830-673EAAB8B86E}"/>
              </a:ext>
            </a:extLst>
          </p:cNvPr>
          <p:cNvSpPr txBox="1"/>
          <p:nvPr/>
        </p:nvSpPr>
        <p:spPr>
          <a:xfrm>
            <a:off x="2581974" y="4034720"/>
            <a:ext cx="175881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RNAPIIpS2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6ED60488-B95D-4892-BF63-E65D8BE5E6DA}"/>
              </a:ext>
            </a:extLst>
          </p:cNvPr>
          <p:cNvSpPr txBox="1"/>
          <p:nvPr/>
        </p:nvSpPr>
        <p:spPr>
          <a:xfrm>
            <a:off x="3353018" y="4553543"/>
            <a:ext cx="98777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SETX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268FF631-9572-4B64-99B0-DF042730BB55}"/>
              </a:ext>
            </a:extLst>
          </p:cNvPr>
          <p:cNvSpPr txBox="1"/>
          <p:nvPr/>
        </p:nvSpPr>
        <p:spPr>
          <a:xfrm>
            <a:off x="3402765" y="4981400"/>
            <a:ext cx="100700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DHX9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A707974B-9E18-4297-AC00-9DA4B684D721}"/>
              </a:ext>
            </a:extLst>
          </p:cNvPr>
          <p:cNvSpPr txBox="1"/>
          <p:nvPr/>
        </p:nvSpPr>
        <p:spPr>
          <a:xfrm>
            <a:off x="3218583" y="5541086"/>
            <a:ext cx="117692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SRSF1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472BDBF7-A175-4C46-A43E-A5792CEBA079}"/>
              </a:ext>
            </a:extLst>
          </p:cNvPr>
          <p:cNvSpPr txBox="1"/>
          <p:nvPr/>
        </p:nvSpPr>
        <p:spPr>
          <a:xfrm>
            <a:off x="3190667" y="6193121"/>
            <a:ext cx="118474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130FA22F-CC2D-4EC8-B17E-F5740F4A5C9D}"/>
              </a:ext>
            </a:extLst>
          </p:cNvPr>
          <p:cNvSpPr txBox="1"/>
          <p:nvPr/>
        </p:nvSpPr>
        <p:spPr>
          <a:xfrm rot="18707189">
            <a:off x="4573593" y="1866017"/>
            <a:ext cx="110799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057F91EE-E8E4-461A-A035-0DC8CF06A459}"/>
              </a:ext>
            </a:extLst>
          </p:cNvPr>
          <p:cNvSpPr txBox="1"/>
          <p:nvPr/>
        </p:nvSpPr>
        <p:spPr>
          <a:xfrm>
            <a:off x="290717" y="118845"/>
            <a:ext cx="4160113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Work Area: Floyd Lab – Drake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Image IDs: 338-339, 341-342, 344-345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ell Line: HeLa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Overexpression: iBRD4 Isoforms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7C171DAE-867B-4B88-B725-FB2B768D397B}"/>
              </a:ext>
            </a:extLst>
          </p:cNvPr>
          <p:cNvSpPr txBox="1"/>
          <p:nvPr/>
        </p:nvSpPr>
        <p:spPr>
          <a:xfrm>
            <a:off x="3540623" y="2073222"/>
            <a:ext cx="8691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6 hrs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38335684-16D8-4BAC-A7E3-B9DA2911C02A}"/>
              </a:ext>
            </a:extLst>
          </p:cNvPr>
          <p:cNvSpPr txBox="1"/>
          <p:nvPr/>
        </p:nvSpPr>
        <p:spPr>
          <a:xfrm rot="18707189">
            <a:off x="5181469" y="1879931"/>
            <a:ext cx="112562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dBET6</a:t>
            </a:r>
          </a:p>
        </p:txBody>
      </p:sp>
      <p:pic>
        <p:nvPicPr>
          <p:cNvPr id="58" name="Picture 57">
            <a:extLst>
              <a:ext uri="{FF2B5EF4-FFF2-40B4-BE49-F238E27FC236}">
                <a16:creationId xmlns:a16="http://schemas.microsoft.com/office/drawing/2014/main" id="{90C04670-AE02-4B26-9E0B-FDC119667D39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450830" y="2798606"/>
            <a:ext cx="1403838" cy="461665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30518069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E9D5F426-DE23-1243-8C3E-95E856DA5BC8}"/>
              </a:ext>
            </a:extLst>
          </p:cNvPr>
          <p:cNvSpPr txBox="1"/>
          <p:nvPr/>
        </p:nvSpPr>
        <p:spPr>
          <a:xfrm>
            <a:off x="2326660" y="2147528"/>
            <a:ext cx="177548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BRD4 Iso 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F5D650C-9E67-B940-8994-145134C18314}"/>
              </a:ext>
            </a:extLst>
          </p:cNvPr>
          <p:cNvSpPr txBox="1"/>
          <p:nvPr/>
        </p:nvSpPr>
        <p:spPr>
          <a:xfrm>
            <a:off x="2326660" y="4133087"/>
            <a:ext cx="181011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BRD4 Iso C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C7F0CD0-1B34-AE44-BBB5-BCE083E7D098}"/>
              </a:ext>
            </a:extLst>
          </p:cNvPr>
          <p:cNvSpPr txBox="1"/>
          <p:nvPr/>
        </p:nvSpPr>
        <p:spPr>
          <a:xfrm>
            <a:off x="2326660" y="1716974"/>
            <a:ext cx="175881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RNAPIIpS2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9EEBF37-B47A-F54C-A894-9B5732719A9B}"/>
              </a:ext>
            </a:extLst>
          </p:cNvPr>
          <p:cNvSpPr txBox="1"/>
          <p:nvPr/>
        </p:nvSpPr>
        <p:spPr>
          <a:xfrm rot="18707189">
            <a:off x="7141495" y="948450"/>
            <a:ext cx="110799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5309C81E-05A0-DD4F-AD58-10EAA48FDA7F}"/>
              </a:ext>
            </a:extLst>
          </p:cNvPr>
          <p:cNvSpPr txBox="1"/>
          <p:nvPr/>
        </p:nvSpPr>
        <p:spPr>
          <a:xfrm>
            <a:off x="290717" y="118845"/>
            <a:ext cx="4160113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Work Area: Floyd Lab – Drake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Image IDs: 338-339, 341-342, 344-345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ell Line: HeLa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C25F75F0-FA79-2C45-B08F-C4CC40E1972D}"/>
              </a:ext>
            </a:extLst>
          </p:cNvPr>
          <p:cNvSpPr txBox="1"/>
          <p:nvPr/>
        </p:nvSpPr>
        <p:spPr>
          <a:xfrm>
            <a:off x="3267354" y="1253415"/>
            <a:ext cx="8691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6 hrs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21301A8-A457-DD4C-BBDE-CC71074EC677}"/>
              </a:ext>
            </a:extLst>
          </p:cNvPr>
          <p:cNvSpPr txBox="1"/>
          <p:nvPr/>
        </p:nvSpPr>
        <p:spPr>
          <a:xfrm rot="18707189">
            <a:off x="8130370" y="910777"/>
            <a:ext cx="112562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dBET6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74D3C9DA-93F7-6F4D-B46F-886C7B09523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02146" y="1746178"/>
            <a:ext cx="4889500" cy="386080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F43BEFE5-31FF-104D-B02D-0CC6E5E73334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64541"/>
          <a:stretch/>
        </p:blipFill>
        <p:spPr>
          <a:xfrm>
            <a:off x="9672827" y="2147528"/>
            <a:ext cx="1094305" cy="3365500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65FCD72E-3829-E34E-A3CF-17931BBB7697}"/>
              </a:ext>
            </a:extLst>
          </p:cNvPr>
          <p:cNvSpPr txBox="1"/>
          <p:nvPr/>
        </p:nvSpPr>
        <p:spPr>
          <a:xfrm>
            <a:off x="4264059" y="6132821"/>
            <a:ext cx="456567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BRD4 (green), RNAPIIpS2 (red)</a:t>
            </a:r>
          </a:p>
        </p:txBody>
      </p:sp>
    </p:spTree>
    <p:extLst>
      <p:ext uri="{BB962C8B-B14F-4D97-AF65-F5344CB8AC3E}">
        <p14:creationId xmlns:p14="http://schemas.microsoft.com/office/powerpoint/2010/main" val="5377706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>
            <a:extLst>
              <a:ext uri="{FF2B5EF4-FFF2-40B4-BE49-F238E27FC236}">
                <a16:creationId xmlns:a16="http://schemas.microsoft.com/office/drawing/2014/main" id="{FF5D650C-9E67-B940-8994-145134C18314}"/>
              </a:ext>
            </a:extLst>
          </p:cNvPr>
          <p:cNvSpPr txBox="1"/>
          <p:nvPr/>
        </p:nvSpPr>
        <p:spPr>
          <a:xfrm>
            <a:off x="2722068" y="3724475"/>
            <a:ext cx="98777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SETX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9EEBF37-B47A-F54C-A894-9B5732719A9B}"/>
              </a:ext>
            </a:extLst>
          </p:cNvPr>
          <p:cNvSpPr txBox="1"/>
          <p:nvPr/>
        </p:nvSpPr>
        <p:spPr>
          <a:xfrm rot="18707189">
            <a:off x="6381893" y="2388368"/>
            <a:ext cx="110799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5309C81E-05A0-DD4F-AD58-10EAA48FDA7F}"/>
              </a:ext>
            </a:extLst>
          </p:cNvPr>
          <p:cNvSpPr txBox="1"/>
          <p:nvPr/>
        </p:nvSpPr>
        <p:spPr>
          <a:xfrm>
            <a:off x="290717" y="118845"/>
            <a:ext cx="4160113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Work Area: Floyd Lab – Drake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Image IDs: 338-339, 341-342, 344-345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ell Line: HeLa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C25F75F0-FA79-2C45-B08F-C4CC40E1972D}"/>
              </a:ext>
            </a:extLst>
          </p:cNvPr>
          <p:cNvSpPr txBox="1"/>
          <p:nvPr/>
        </p:nvSpPr>
        <p:spPr>
          <a:xfrm>
            <a:off x="2722068" y="2849955"/>
            <a:ext cx="8691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6 hrs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21301A8-A457-DD4C-BBDE-CC71074EC677}"/>
              </a:ext>
            </a:extLst>
          </p:cNvPr>
          <p:cNvSpPr txBox="1"/>
          <p:nvPr/>
        </p:nvSpPr>
        <p:spPr>
          <a:xfrm rot="18707189">
            <a:off x="7102917" y="2342996"/>
            <a:ext cx="112562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dBET6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F43BEFE5-31FF-104D-B02D-0CC6E5E7333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4541"/>
          <a:stretch/>
        </p:blipFill>
        <p:spPr>
          <a:xfrm>
            <a:off x="9672827" y="2147528"/>
            <a:ext cx="1094305" cy="3365500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416A7597-DD95-A044-B7AF-B5487591C60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758698" y="3282712"/>
            <a:ext cx="4394200" cy="1587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0157045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>
            <a:extLst>
              <a:ext uri="{FF2B5EF4-FFF2-40B4-BE49-F238E27FC236}">
                <a16:creationId xmlns:a16="http://schemas.microsoft.com/office/drawing/2014/main" id="{FF5D650C-9E67-B940-8994-145134C18314}"/>
              </a:ext>
            </a:extLst>
          </p:cNvPr>
          <p:cNvSpPr txBox="1"/>
          <p:nvPr/>
        </p:nvSpPr>
        <p:spPr>
          <a:xfrm>
            <a:off x="2944570" y="3809298"/>
            <a:ext cx="100700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DHX9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9EEBF37-B47A-F54C-A894-9B5732719A9B}"/>
              </a:ext>
            </a:extLst>
          </p:cNvPr>
          <p:cNvSpPr txBox="1"/>
          <p:nvPr/>
        </p:nvSpPr>
        <p:spPr>
          <a:xfrm rot="18707189">
            <a:off x="6518528" y="2440314"/>
            <a:ext cx="110799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5309C81E-05A0-DD4F-AD58-10EAA48FDA7F}"/>
              </a:ext>
            </a:extLst>
          </p:cNvPr>
          <p:cNvSpPr txBox="1"/>
          <p:nvPr/>
        </p:nvSpPr>
        <p:spPr>
          <a:xfrm>
            <a:off x="290717" y="118845"/>
            <a:ext cx="4160113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Work Area: Floyd Lab – Drake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Image IDs: 338-339, 341-342, 344-345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ell Line: HeLa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C25F75F0-FA79-2C45-B08F-C4CC40E1972D}"/>
              </a:ext>
            </a:extLst>
          </p:cNvPr>
          <p:cNvSpPr txBox="1"/>
          <p:nvPr/>
        </p:nvSpPr>
        <p:spPr>
          <a:xfrm>
            <a:off x="2722068" y="2849955"/>
            <a:ext cx="8691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6 hrs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21301A8-A457-DD4C-BBDE-CC71074EC677}"/>
              </a:ext>
            </a:extLst>
          </p:cNvPr>
          <p:cNvSpPr txBox="1"/>
          <p:nvPr/>
        </p:nvSpPr>
        <p:spPr>
          <a:xfrm rot="18707189">
            <a:off x="7533348" y="2394940"/>
            <a:ext cx="112562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dBET6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F43BEFE5-31FF-104D-B02D-0CC6E5E7333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4541"/>
          <a:stretch/>
        </p:blipFill>
        <p:spPr>
          <a:xfrm>
            <a:off x="9672827" y="2147528"/>
            <a:ext cx="1094305" cy="336550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CE85CC64-9F6C-4365-864D-25920B3985F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031130" y="3311620"/>
            <a:ext cx="4181754" cy="19186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1820092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>
            <a:extLst>
              <a:ext uri="{FF2B5EF4-FFF2-40B4-BE49-F238E27FC236}">
                <a16:creationId xmlns:a16="http://schemas.microsoft.com/office/drawing/2014/main" id="{FF5D650C-9E67-B940-8994-145134C18314}"/>
              </a:ext>
            </a:extLst>
          </p:cNvPr>
          <p:cNvSpPr txBox="1"/>
          <p:nvPr/>
        </p:nvSpPr>
        <p:spPr>
          <a:xfrm>
            <a:off x="4212536" y="2841606"/>
            <a:ext cx="117692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SRSF1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9EEBF37-B47A-F54C-A894-9B5732719A9B}"/>
              </a:ext>
            </a:extLst>
          </p:cNvPr>
          <p:cNvSpPr txBox="1"/>
          <p:nvPr/>
        </p:nvSpPr>
        <p:spPr>
          <a:xfrm rot="18707189">
            <a:off x="6379925" y="1037133"/>
            <a:ext cx="110799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5309C81E-05A0-DD4F-AD58-10EAA48FDA7F}"/>
              </a:ext>
            </a:extLst>
          </p:cNvPr>
          <p:cNvSpPr txBox="1"/>
          <p:nvPr/>
        </p:nvSpPr>
        <p:spPr>
          <a:xfrm>
            <a:off x="290717" y="118845"/>
            <a:ext cx="4160113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Work Area: Floyd Lab – Drake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Image IDs: 338-339, 341-342, 344-345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ell Line: HeLa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C25F75F0-FA79-2C45-B08F-C4CC40E1972D}"/>
              </a:ext>
            </a:extLst>
          </p:cNvPr>
          <p:cNvSpPr txBox="1"/>
          <p:nvPr/>
        </p:nvSpPr>
        <p:spPr>
          <a:xfrm>
            <a:off x="4212536" y="1343318"/>
            <a:ext cx="8691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6 hrs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21301A8-A457-DD4C-BBDE-CC71074EC677}"/>
              </a:ext>
            </a:extLst>
          </p:cNvPr>
          <p:cNvSpPr txBox="1"/>
          <p:nvPr/>
        </p:nvSpPr>
        <p:spPr>
          <a:xfrm rot="18707189">
            <a:off x="7100949" y="991761"/>
            <a:ext cx="112562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dBET6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F43BEFE5-31FF-104D-B02D-0CC6E5E7333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4541"/>
          <a:stretch/>
        </p:blipFill>
        <p:spPr>
          <a:xfrm>
            <a:off x="9672827" y="2147528"/>
            <a:ext cx="1094305" cy="336550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0E02D895-236D-6544-8CBC-32075B8478A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518672" y="1796063"/>
            <a:ext cx="2222500" cy="4445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6661901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>
            <a:extLst>
              <a:ext uri="{FF2B5EF4-FFF2-40B4-BE49-F238E27FC236}">
                <a16:creationId xmlns:a16="http://schemas.microsoft.com/office/drawing/2014/main" id="{FF5D650C-9E67-B940-8994-145134C18314}"/>
              </a:ext>
            </a:extLst>
          </p:cNvPr>
          <p:cNvSpPr txBox="1"/>
          <p:nvPr/>
        </p:nvSpPr>
        <p:spPr>
          <a:xfrm>
            <a:off x="3266082" y="2556535"/>
            <a:ext cx="118474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9EEBF37-B47A-F54C-A894-9B5732719A9B}"/>
              </a:ext>
            </a:extLst>
          </p:cNvPr>
          <p:cNvSpPr txBox="1"/>
          <p:nvPr/>
        </p:nvSpPr>
        <p:spPr>
          <a:xfrm rot="18707189">
            <a:off x="6224238" y="580588"/>
            <a:ext cx="110799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5309C81E-05A0-DD4F-AD58-10EAA48FDA7F}"/>
              </a:ext>
            </a:extLst>
          </p:cNvPr>
          <p:cNvSpPr txBox="1"/>
          <p:nvPr/>
        </p:nvSpPr>
        <p:spPr>
          <a:xfrm>
            <a:off x="290717" y="118845"/>
            <a:ext cx="4160113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Work Area: Floyd Lab – Drake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Image IDs: 338-339, 341-342, 344-345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ell Line: HeLa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C25F75F0-FA79-2C45-B08F-C4CC40E1972D}"/>
              </a:ext>
            </a:extLst>
          </p:cNvPr>
          <p:cNvSpPr txBox="1"/>
          <p:nvPr/>
        </p:nvSpPr>
        <p:spPr>
          <a:xfrm>
            <a:off x="3267354" y="1253415"/>
            <a:ext cx="8691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6 hrs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21301A8-A457-DD4C-BBDE-CC71074EC677}"/>
              </a:ext>
            </a:extLst>
          </p:cNvPr>
          <p:cNvSpPr txBox="1"/>
          <p:nvPr/>
        </p:nvSpPr>
        <p:spPr>
          <a:xfrm rot="18707189">
            <a:off x="6945262" y="535216"/>
            <a:ext cx="112562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dBET6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F43BEFE5-31FF-104D-B02D-0CC6E5E7333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4541"/>
          <a:stretch/>
        </p:blipFill>
        <p:spPr>
          <a:xfrm>
            <a:off x="9672827" y="2147528"/>
            <a:ext cx="1094305" cy="336550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31714871-1136-974E-959A-2D0321678F8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616450" y="1287574"/>
            <a:ext cx="2959100" cy="447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824823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0</TotalTime>
  <Words>177</Words>
  <Application>Microsoft Office PowerPoint</Application>
  <PresentationFormat>Widescreen</PresentationFormat>
  <Paragraphs>57</Paragraphs>
  <Slides>6</Slides>
  <Notes>5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ake Edwards</dc:creator>
  <cp:lastModifiedBy>Drake Edwards</cp:lastModifiedBy>
  <cp:revision>10</cp:revision>
  <dcterms:created xsi:type="dcterms:W3CDTF">2019-10-08T13:14:11Z</dcterms:created>
  <dcterms:modified xsi:type="dcterms:W3CDTF">2020-04-13T03:49:35Z</dcterms:modified>
</cp:coreProperties>
</file>